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270" autoAdjust="0"/>
  </p:normalViewPr>
  <p:slideViewPr>
    <p:cSldViewPr showGuides="1">
      <p:cViewPr>
        <p:scale>
          <a:sx n="98" d="100"/>
          <a:sy n="98" d="100"/>
        </p:scale>
        <p:origin x="-208" y="-5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235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17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642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76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772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325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9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770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250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897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405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B4995E-084C-4676-A12C-A66D132ACDAF}" type="datetimeFigureOut">
              <a:rPr lang="en-US" smtClean="0"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C9CB5-5BBC-47D8-A026-CC20C6236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943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71174" y="5300870"/>
            <a:ext cx="4982478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Additional file 3.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DS-PAGE showing the degree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of </a:t>
            </a:r>
            <a:r>
              <a:rPr lang="en-US" sz="1200" b="1" dirty="0"/>
              <a:t>purification of </a:t>
            </a:r>
            <a:r>
              <a:rPr lang="en-US" sz="1200" b="1" dirty="0">
                <a:latin typeface="Symbol" charset="2"/>
                <a:cs typeface="Symbol" charset="2"/>
              </a:rPr>
              <a:t>D</a:t>
            </a:r>
            <a:r>
              <a:rPr lang="en-US" sz="1200" b="1" baseline="-25000" dirty="0"/>
              <a:t>1-26</a:t>
            </a:r>
            <a:r>
              <a:rPr lang="en-US" sz="1200" b="1" i="1" dirty="0"/>
              <a:t>Ptxt</a:t>
            </a:r>
            <a:r>
              <a:rPr lang="en-US" sz="1200" b="1" dirty="0"/>
              <a:t>PL1-27 expressed in </a:t>
            </a:r>
            <a:r>
              <a:rPr lang="en-US" sz="1200" b="1" i="1" dirty="0"/>
              <a:t>E. coli</a:t>
            </a:r>
            <a:r>
              <a:rPr lang="en-US" sz="1200" b="1" dirty="0"/>
              <a:t>.</a:t>
            </a:r>
            <a:r>
              <a:rPr lang="en-US" sz="1200" dirty="0"/>
              <a:t>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Ptxt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L1-27 protein was expressed in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. col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using pTYB11 vector and partially purified by affinity chromatography.  Proteins were separated by gel electrophoresis and stain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oomassi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Lane 1: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Proteins extracted from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. coli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xpressing recombinant protein  before induction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; Lane 2: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Proteins extracted from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. coli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xpressing recombinant protein after induction by 0.3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m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PTG.  The induced product can be seen at 98.8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olypeptide representing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Ptx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tPL1-27 fused to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ntei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chitin binding doma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;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Lane 3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artially purified recombinant protein is shown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s 41.2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kD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band.  The preparation is contaminated mainly by the 56.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olypeptide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containing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ntei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hitin binding domain, which is the cleavage product of 98.8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combinant polypeptide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 15"/>
          <p:cNvGrpSpPr/>
          <p:nvPr/>
        </p:nvGrpSpPr>
        <p:grpSpPr>
          <a:xfrm>
            <a:off x="2132856" y="1150794"/>
            <a:ext cx="1844376" cy="3650955"/>
            <a:chOff x="2164080" y="1210109"/>
            <a:chExt cx="1844376" cy="365095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64080" y="1538744"/>
              <a:ext cx="1264920" cy="332232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474404" y="1210109"/>
              <a:ext cx="9545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1   2   3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451680" y="2204755"/>
              <a:ext cx="5340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>
                  <a:latin typeface="Arial"/>
                  <a:cs typeface="Arial"/>
                </a:rPr>
                <a:t>98.8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451680" y="3009868"/>
              <a:ext cx="5340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56.0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474360" y="3435909"/>
              <a:ext cx="5340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41.2</a:t>
              </a:r>
              <a:endParaRPr lang="en-US" sz="1400" dirty="0">
                <a:latin typeface="Arial"/>
                <a:cs typeface="Arial"/>
              </a:endParaRPr>
            </a:p>
          </p:txBody>
        </p:sp>
        <p:cxnSp>
          <p:nvCxnSpPr>
            <p:cNvPr id="11" name="Straight Connector 10"/>
            <p:cNvCxnSpPr>
              <a:stCxn id="8" idx="1"/>
            </p:cNvCxnSpPr>
            <p:nvPr/>
          </p:nvCxnSpPr>
          <p:spPr>
            <a:xfrm rot="10800000" flipV="1">
              <a:off x="3150612" y="2358643"/>
              <a:ext cx="301068" cy="1"/>
            </a:xfrm>
            <a:prstGeom prst="line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" name="Straight Connector 11"/>
          <p:cNvCxnSpPr/>
          <p:nvPr/>
        </p:nvCxnSpPr>
        <p:spPr>
          <a:xfrm rot="10800000" flipV="1">
            <a:off x="4005064" y="3563888"/>
            <a:ext cx="301068" cy="1"/>
          </a:xfrm>
          <a:prstGeom prst="line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4437112" y="3347864"/>
            <a:ext cx="15311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rget prote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65548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61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me</dc:creator>
  <cp:lastModifiedBy>Ewa Mellerowicz</cp:lastModifiedBy>
  <cp:revision>8</cp:revision>
  <dcterms:created xsi:type="dcterms:W3CDTF">2013-10-31T19:30:41Z</dcterms:created>
  <dcterms:modified xsi:type="dcterms:W3CDTF">2013-12-16T16:57:00Z</dcterms:modified>
</cp:coreProperties>
</file>